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7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355" autoAdjust="0"/>
  </p:normalViewPr>
  <p:slideViewPr>
    <p:cSldViewPr snapToGrid="0" snapToObjects="1">
      <p:cViewPr>
        <p:scale>
          <a:sx n="94" d="100"/>
          <a:sy n="94" d="100"/>
        </p:scale>
        <p:origin x="-1176" y="-2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654DB2-302E-B242-9863-3DC657121B1F}" type="datetimeFigureOut">
              <a:rPr lang="en-US" smtClean="0"/>
              <a:t>5/1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25A517-2AAD-3A45-8F1A-EDE64F62C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947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25A517-2AAD-3A45-8F1A-EDE64F62CD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13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089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522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24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544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728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661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28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629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8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87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040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E89AE-47B6-1347-9772-84BD481F14F3}" type="datetimeFigureOut">
              <a:rPr lang="en-US" smtClean="0"/>
              <a:t>5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1F0B2-22CF-AD4A-B898-664E4085FD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545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5" descr="dfci.rfs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1236" y="4202590"/>
            <a:ext cx="2993126" cy="2078560"/>
          </a:xfrm>
          <a:prstGeom prst="rect">
            <a:avLst/>
          </a:prstGeom>
        </p:spPr>
      </p:pic>
      <p:pic>
        <p:nvPicPr>
          <p:cNvPr id="45" name="Picture 44" descr="km.os.mi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6254" y="2174510"/>
            <a:ext cx="2993126" cy="2078560"/>
          </a:xfrm>
          <a:prstGeom prst="rect">
            <a:avLst/>
          </a:prstGeom>
        </p:spPr>
      </p:pic>
      <p:pic>
        <p:nvPicPr>
          <p:cNvPr id="44" name="Picture 43" descr="km.dss.mi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657" y="2174510"/>
            <a:ext cx="2993126" cy="2078560"/>
          </a:xfrm>
          <a:prstGeom prst="rect">
            <a:avLst/>
          </a:prstGeom>
        </p:spPr>
      </p:pic>
      <p:pic>
        <p:nvPicPr>
          <p:cNvPr id="25" name="Picture 24" descr="km.os.nmi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6254" y="324738"/>
            <a:ext cx="2993126" cy="2078560"/>
          </a:xfrm>
          <a:prstGeom prst="rect">
            <a:avLst/>
          </a:prstGeom>
        </p:spPr>
      </p:pic>
      <p:pic>
        <p:nvPicPr>
          <p:cNvPr id="24" name="Picture 23" descr="km.dss.nmi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665" y="329040"/>
            <a:ext cx="2993126" cy="2078560"/>
          </a:xfrm>
          <a:prstGeom prst="rect">
            <a:avLst/>
          </a:prstGeom>
        </p:spPr>
      </p:pic>
      <p:sp>
        <p:nvSpPr>
          <p:cNvPr id="8" name="TextBox 8"/>
          <p:cNvSpPr txBox="1">
            <a:spLocks noChangeArrowheads="1"/>
          </p:cNvSpPr>
          <p:nvPr/>
        </p:nvSpPr>
        <p:spPr bwMode="auto">
          <a:xfrm>
            <a:off x="67230" y="45093"/>
            <a:ext cx="2055558" cy="3693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  <a:latin typeface="+mj-lt"/>
                <a:cs typeface="Arial" pitchFamily="34" charset="0"/>
              </a:rPr>
              <a:t>Supporting Figure </a:t>
            </a:r>
            <a:r>
              <a:rPr lang="en-US" b="1" dirty="0">
                <a:solidFill>
                  <a:schemeClr val="bg1"/>
                </a:solidFill>
                <a:latin typeface="+mj-lt"/>
                <a:cs typeface="Arial" pitchFamily="34" charset="0"/>
              </a:rPr>
              <a:t>1</a:t>
            </a:r>
          </a:p>
        </p:txBody>
      </p:sp>
      <p:sp>
        <p:nvSpPr>
          <p:cNvPr id="9" name="TextBox 8"/>
          <p:cNvSpPr txBox="1">
            <a:spLocks noChangeArrowheads="1"/>
          </p:cNvSpPr>
          <p:nvPr/>
        </p:nvSpPr>
        <p:spPr bwMode="auto">
          <a:xfrm>
            <a:off x="174767" y="607176"/>
            <a:ext cx="325730" cy="3693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  <a:latin typeface="+mj-lt"/>
                <a:cs typeface="Arial" pitchFamily="34" charset="0"/>
              </a:rPr>
              <a:t>A</a:t>
            </a:r>
            <a:endParaRPr lang="en-US" b="1" dirty="0">
              <a:solidFill>
                <a:schemeClr val="bg1"/>
              </a:solidFill>
              <a:latin typeface="+mj-lt"/>
              <a:cs typeface="Arial" pitchFamily="34" charset="0"/>
            </a:endParaRPr>
          </a:p>
        </p:txBody>
      </p:sp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174767" y="2619482"/>
            <a:ext cx="314058" cy="3693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+mj-lt"/>
                <a:cs typeface="Arial" pitchFamily="34" charset="0"/>
              </a:rPr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273452" y="944257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SS (%)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920108" y="2079248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onths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3362590" y="944257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</a:t>
            </a:r>
            <a:r>
              <a:rPr lang="en-US" sz="1400" b="1" dirty="0" smtClean="0"/>
              <a:t>S (%)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004528" y="2079248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onths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320903" y="1345538"/>
            <a:ext cx="9525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R = 1.99</a:t>
            </a:r>
          </a:p>
          <a:p>
            <a:r>
              <a:rPr lang="en-US" sz="1200" b="1" dirty="0" smtClean="0"/>
              <a:t>P = 0.572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297232" y="1345538"/>
            <a:ext cx="9525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R = 1.32</a:t>
            </a:r>
          </a:p>
          <a:p>
            <a:r>
              <a:rPr lang="en-US" sz="1200" b="1" dirty="0" smtClean="0"/>
              <a:t>P = 0.419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320903" y="3173172"/>
            <a:ext cx="9525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R = 1.02</a:t>
            </a:r>
          </a:p>
          <a:p>
            <a:r>
              <a:rPr lang="en-US" sz="1200" b="1" dirty="0" smtClean="0"/>
              <a:t>P = 0.958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405323" y="3216987"/>
            <a:ext cx="9525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R =0.87</a:t>
            </a:r>
          </a:p>
          <a:p>
            <a:r>
              <a:rPr lang="en-US" sz="1200" b="1" dirty="0" smtClean="0"/>
              <a:t>P = 0.702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290732" y="2731367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SS (%)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352846" y="2731367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</a:t>
            </a:r>
            <a:r>
              <a:rPr lang="en-US" sz="1400" b="1" dirty="0" smtClean="0"/>
              <a:t>S (%)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1923876" y="3933908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onths</a:t>
            </a:r>
            <a:endParaRPr lang="en-US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5008296" y="3933908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onths</a:t>
            </a:r>
            <a:endParaRPr lang="en-US" sz="1400" b="1" dirty="0"/>
          </a:p>
        </p:txBody>
      </p:sp>
      <p:pic>
        <p:nvPicPr>
          <p:cNvPr id="3" name="Picture 2" descr="legend2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0388" y="1368804"/>
            <a:ext cx="423949" cy="39069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40289" y="1282465"/>
            <a:ext cx="421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No</a:t>
            </a:r>
            <a:endParaRPr lang="en-US" sz="14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7640289" y="1454516"/>
            <a:ext cx="566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Yes</a:t>
            </a:r>
            <a:endParaRPr 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7024279" y="822370"/>
            <a:ext cx="13892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CG therapy </a:t>
            </a:r>
          </a:p>
          <a:p>
            <a:r>
              <a:rPr lang="en-US" sz="1400" b="1" dirty="0" smtClean="0"/>
              <a:t>(NMI patients) </a:t>
            </a:r>
            <a:endParaRPr lang="en-US" sz="1400" b="1" dirty="0"/>
          </a:p>
        </p:txBody>
      </p:sp>
      <p:sp>
        <p:nvSpPr>
          <p:cNvPr id="5" name="Rectangle 4"/>
          <p:cNvSpPr/>
          <p:nvPr/>
        </p:nvSpPr>
        <p:spPr>
          <a:xfrm>
            <a:off x="7024279" y="808860"/>
            <a:ext cx="1277386" cy="10452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" name="Picture 29" descr="legend2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3364" y="3300276"/>
            <a:ext cx="423949" cy="390698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7613265" y="3213937"/>
            <a:ext cx="421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No</a:t>
            </a:r>
            <a:endParaRPr lang="en-US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7613265" y="3385988"/>
            <a:ext cx="566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Yes</a:t>
            </a:r>
            <a:endParaRPr lang="en-US" sz="14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7024279" y="2564702"/>
            <a:ext cx="13892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/>
              <a:t>Advjuvant</a:t>
            </a:r>
            <a:r>
              <a:rPr lang="en-US" sz="1400" b="1" dirty="0" smtClean="0"/>
              <a:t> chemotherapy </a:t>
            </a:r>
          </a:p>
          <a:p>
            <a:r>
              <a:rPr lang="en-US" sz="1400" b="1" dirty="0" smtClean="0"/>
              <a:t>(MI patients) </a:t>
            </a:r>
            <a:endParaRPr lang="en-US" sz="1400" b="1" dirty="0"/>
          </a:p>
        </p:txBody>
      </p:sp>
      <p:sp>
        <p:nvSpPr>
          <p:cNvPr id="39" name="Rectangle 38"/>
          <p:cNvSpPr/>
          <p:nvPr/>
        </p:nvSpPr>
        <p:spPr>
          <a:xfrm>
            <a:off x="7024279" y="2479300"/>
            <a:ext cx="1277386" cy="13063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2355719" y="5362447"/>
            <a:ext cx="1549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R = 4.23, P &lt; 0.001</a:t>
            </a:r>
            <a:endParaRPr lang="en-US" sz="1200" b="1" dirty="0"/>
          </a:p>
        </p:txBody>
      </p:sp>
      <p:pic>
        <p:nvPicPr>
          <p:cNvPr id="48" name="Picture 47" descr="legend2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6864" y="5356303"/>
            <a:ext cx="423949" cy="390698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5576764" y="5269964"/>
            <a:ext cx="2300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No  (42% N+ or M+)</a:t>
            </a:r>
            <a:endParaRPr lang="en-US" sz="14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5576764" y="5442015"/>
            <a:ext cx="1904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Yes (84% N+ or M+)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5041827" y="4823379"/>
            <a:ext cx="26150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/>
              <a:t>Advjuvant</a:t>
            </a:r>
            <a:r>
              <a:rPr lang="en-US" sz="1400" b="1" dirty="0" smtClean="0"/>
              <a:t> chemotherapy </a:t>
            </a:r>
          </a:p>
          <a:p>
            <a:r>
              <a:rPr lang="en-US" sz="1400" b="1" dirty="0" smtClean="0"/>
              <a:t>(MI patients) </a:t>
            </a:r>
            <a:endParaRPr lang="en-US" sz="1400" b="1" dirty="0"/>
          </a:p>
        </p:txBody>
      </p:sp>
      <p:sp>
        <p:nvSpPr>
          <p:cNvPr id="52" name="Rectangle 51"/>
          <p:cNvSpPr/>
          <p:nvPr/>
        </p:nvSpPr>
        <p:spPr>
          <a:xfrm>
            <a:off x="5041826" y="4737977"/>
            <a:ext cx="2349026" cy="10523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2846426" y="5973373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onths</a:t>
            </a:r>
            <a:endParaRPr lang="en-US" sz="1400" b="1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1310273" y="4851107"/>
            <a:ext cx="7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RFS (%)</a:t>
            </a:r>
            <a:endParaRPr lang="en-US" sz="1400" b="1" dirty="0"/>
          </a:p>
        </p:txBody>
      </p:sp>
      <p:sp>
        <p:nvSpPr>
          <p:cNvPr id="55" name="TextBox 54"/>
          <p:cNvSpPr txBox="1">
            <a:spLocks noChangeArrowheads="1"/>
          </p:cNvSpPr>
          <p:nvPr/>
        </p:nvSpPr>
        <p:spPr bwMode="auto">
          <a:xfrm>
            <a:off x="222132" y="4421248"/>
            <a:ext cx="306845" cy="3693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+mj-lt"/>
                <a:cs typeface="Arial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281018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2</TotalTime>
  <Words>105</Words>
  <Application>Microsoft Macintosh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rett Dancik</dc:creator>
  <cp:lastModifiedBy>Garrett Dancik</cp:lastModifiedBy>
  <cp:revision>867</cp:revision>
  <dcterms:created xsi:type="dcterms:W3CDTF">2014-06-22T17:45:12Z</dcterms:created>
  <dcterms:modified xsi:type="dcterms:W3CDTF">2015-05-19T19:14:37Z</dcterms:modified>
</cp:coreProperties>
</file>